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84" r:id="rId5"/>
    <p:sldId id="288" r:id="rId6"/>
    <p:sldId id="286" r:id="rId7"/>
    <p:sldId id="291" r:id="rId8"/>
    <p:sldId id="293" r:id="rId9"/>
    <p:sldId id="292" r:id="rId10"/>
    <p:sldId id="295" r:id="rId11"/>
    <p:sldId id="296" r:id="rId12"/>
    <p:sldId id="294" r:id="rId13"/>
    <p:sldId id="272" r:id="rId14"/>
    <p:sldId id="273" r:id="rId15"/>
    <p:sldId id="274" r:id="rId16"/>
    <p:sldId id="275" r:id="rId17"/>
    <p:sldId id="276" r:id="rId1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1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6/11/relationships/changesInfo" Target="changesInfos/changesInfo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copo Boni" userId="3468928e-f576-476d-811b-ea8091bad45a" providerId="ADAL" clId="{A57800CA-4072-4B01-99D3-B58C761CB754}"/>
    <pc:docChg chg="undo custSel addSld delSld modSld">
      <pc:chgData name="Jacopo Boni" userId="3468928e-f576-476d-811b-ea8091bad45a" providerId="ADAL" clId="{A57800CA-4072-4B01-99D3-B58C761CB754}" dt="2025-07-25T13:30:17.809" v="327" actId="14100"/>
      <pc:docMkLst>
        <pc:docMk/>
      </pc:docMkLst>
      <pc:sldChg chg="modSp mod">
        <pc:chgData name="Jacopo Boni" userId="3468928e-f576-476d-811b-ea8091bad45a" providerId="ADAL" clId="{A57800CA-4072-4B01-99D3-B58C761CB754}" dt="2025-07-25T13:11:22.803" v="181" actId="14100"/>
        <pc:sldMkLst>
          <pc:docMk/>
          <pc:sldMk cId="1899656772" sldId="257"/>
        </pc:sldMkLst>
      </pc:sldChg>
      <pc:sldChg chg="addSp delSp modSp mod">
        <pc:chgData name="Jacopo Boni" userId="3468928e-f576-476d-811b-ea8091bad45a" providerId="ADAL" clId="{A57800CA-4072-4B01-99D3-B58C761CB754}" dt="2025-07-25T12:33:10.854" v="113" actId="732"/>
        <pc:sldMkLst>
          <pc:docMk/>
          <pc:sldMk cId="849156004" sldId="276"/>
        </pc:sldMkLst>
      </pc:sldChg>
      <pc:sldChg chg="addSp modSp mod">
        <pc:chgData name="Jacopo Boni" userId="3468928e-f576-476d-811b-ea8091bad45a" providerId="ADAL" clId="{A57800CA-4072-4B01-99D3-B58C761CB754}" dt="2025-07-25T13:27:02.726" v="320" actId="1076"/>
        <pc:sldMkLst>
          <pc:docMk/>
          <pc:sldMk cId="989154112" sldId="278"/>
        </pc:sldMkLst>
      </pc:sldChg>
      <pc:sldChg chg="addSp delSp modSp mod">
        <pc:chgData name="Jacopo Boni" userId="3468928e-f576-476d-811b-ea8091bad45a" providerId="ADAL" clId="{A57800CA-4072-4B01-99D3-B58C761CB754}" dt="2025-07-25T13:30:17.809" v="327" actId="14100"/>
        <pc:sldMkLst>
          <pc:docMk/>
          <pc:sldMk cId="1574192415" sldId="279"/>
        </pc:sldMkLst>
      </pc:sldChg>
      <pc:sldChg chg="addSp delSp modSp add del mod">
        <pc:chgData name="Jacopo Boni" userId="3468928e-f576-476d-811b-ea8091bad45a" providerId="ADAL" clId="{A57800CA-4072-4B01-99D3-B58C761CB754}" dt="2025-07-25T12:51:25.652" v="163" actId="478"/>
        <pc:sldMkLst>
          <pc:docMk/>
          <pc:sldMk cId="2685193683" sldId="282"/>
        </pc:sldMkLst>
      </pc:sldChg>
      <pc:sldChg chg="addSp modSp add del mod">
        <pc:chgData name="Jacopo Boni" userId="3468928e-f576-476d-811b-ea8091bad45a" providerId="ADAL" clId="{A57800CA-4072-4B01-99D3-B58C761CB754}" dt="2025-07-25T12:56:35.608" v="175" actId="1076"/>
        <pc:sldMkLst>
          <pc:docMk/>
          <pc:sldMk cId="3959166534" sldId="283"/>
        </pc:sldMkLst>
      </pc:sldChg>
      <pc:sldChg chg="addSp delSp modSp mod">
        <pc:chgData name="Jacopo Boni" userId="3468928e-f576-476d-811b-ea8091bad45a" providerId="ADAL" clId="{A57800CA-4072-4B01-99D3-B58C761CB754}" dt="2025-07-25T12:30:28.818" v="82" actId="478"/>
        <pc:sldMkLst>
          <pc:docMk/>
          <pc:sldMk cId="2388881966" sldId="286"/>
        </pc:sldMkLst>
      </pc:sldChg>
      <pc:sldChg chg="delSp modSp mod">
        <pc:chgData name="Jacopo Boni" userId="3468928e-f576-476d-811b-ea8091bad45a" providerId="ADAL" clId="{A57800CA-4072-4B01-99D3-B58C761CB754}" dt="2025-07-25T12:30:35.389" v="84" actId="478"/>
        <pc:sldMkLst>
          <pc:docMk/>
          <pc:sldMk cId="3491293808" sldId="292"/>
        </pc:sldMkLst>
      </pc:sldChg>
      <pc:sldChg chg="delSp mod">
        <pc:chgData name="Jacopo Boni" userId="3468928e-f576-476d-811b-ea8091bad45a" providerId="ADAL" clId="{A57800CA-4072-4B01-99D3-B58C761CB754}" dt="2025-07-25T12:30:33.021" v="83" actId="478"/>
        <pc:sldMkLst>
          <pc:docMk/>
          <pc:sldMk cId="1938919551" sldId="293"/>
        </pc:sldMkLst>
      </pc:sldChg>
      <pc:sldChg chg="delSp modSp mod">
        <pc:chgData name="Jacopo Boni" userId="3468928e-f576-476d-811b-ea8091bad45a" providerId="ADAL" clId="{A57800CA-4072-4B01-99D3-B58C761CB754}" dt="2025-07-25T12:30:43.190" v="85" actId="478"/>
        <pc:sldMkLst>
          <pc:docMk/>
          <pc:sldMk cId="2278150265" sldId="294"/>
        </pc:sldMkLst>
      </pc:sldChg>
      <pc:sldChg chg="addSp delSp modSp add mod">
        <pc:chgData name="Jacopo Boni" userId="3468928e-f576-476d-811b-ea8091bad45a" providerId="ADAL" clId="{A57800CA-4072-4B01-99D3-B58C761CB754}" dt="2025-07-25T12:56:18.031" v="174" actId="14100"/>
        <pc:sldMkLst>
          <pc:docMk/>
          <pc:sldMk cId="1510078259" sldId="299"/>
        </pc:sldMkLst>
      </pc:sldChg>
      <pc:sldChg chg="addSp delSp modSp add mod">
        <pc:chgData name="Jacopo Boni" userId="3468928e-f576-476d-811b-ea8091bad45a" providerId="ADAL" clId="{A57800CA-4072-4B01-99D3-B58C761CB754}" dt="2025-07-25T12:54:58.422" v="169" actId="14100"/>
        <pc:sldMkLst>
          <pc:docMk/>
          <pc:sldMk cId="1256841142" sldId="300"/>
        </pc:sldMkLst>
      </pc:sldChg>
      <pc:sldChg chg="addSp delSp modSp add mod">
        <pc:chgData name="Jacopo Boni" userId="3468928e-f576-476d-811b-ea8091bad45a" providerId="ADAL" clId="{A57800CA-4072-4B01-99D3-B58C761CB754}" dt="2025-07-25T13:17:18.484" v="257" actId="1076"/>
        <pc:sldMkLst>
          <pc:docMk/>
          <pc:sldMk cId="1296663075" sldId="301"/>
        </pc:sldMkLst>
      </pc:sldChg>
      <pc:sldChg chg="delSp modSp add mod">
        <pc:chgData name="Jacopo Boni" userId="3468928e-f576-476d-811b-ea8091bad45a" providerId="ADAL" clId="{A57800CA-4072-4B01-99D3-B58C761CB754}" dt="2025-07-25T13:16:46.474" v="250" actId="1035"/>
        <pc:sldMkLst>
          <pc:docMk/>
          <pc:sldMk cId="2571517090" sldId="302"/>
        </pc:sldMkLst>
      </pc:sldChg>
      <pc:sldChg chg="addSp delSp modSp add mod">
        <pc:chgData name="Jacopo Boni" userId="3468928e-f576-476d-811b-ea8091bad45a" providerId="ADAL" clId="{A57800CA-4072-4B01-99D3-B58C761CB754}" dt="2025-07-25T13:25:08.855" v="294" actId="1076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A25DEC5B-0D96-964B-8538-CEEE1D0657B9}"/>
    <pc:docChg chg="modSld">
      <pc:chgData name="Míriam Fernández González" userId="S::mfernandez@idibell.cat::352a0393-308e-4058-8495-78b481706071" providerId="AD" clId="Web-{A25DEC5B-0D96-964B-8538-CEEE1D0657B9}" dt="2025-07-24T14:40:25.906" v="11"/>
      <pc:docMkLst>
        <pc:docMk/>
      </pc:docMkLst>
      <pc:sldChg chg="delSp modSp">
        <pc:chgData name="Míriam Fernández González" userId="S::mfernandez@idibell.cat::352a0393-308e-4058-8495-78b481706071" providerId="AD" clId="Web-{A25DEC5B-0D96-964B-8538-CEEE1D0657B9}" dt="2025-07-24T14:40:15.109" v="5" actId="20577"/>
        <pc:sldMkLst>
          <pc:docMk/>
          <pc:sldMk cId="989154112" sldId="278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09.328" v="2" actId="20577"/>
        <pc:sldMkLst>
          <pc:docMk/>
          <pc:sldMk cId="1574192415" sldId="279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0.016" v="8" actId="20577"/>
        <pc:sldMkLst>
          <pc:docMk/>
          <pc:sldMk cId="2685193683" sldId="282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5.906" v="11"/>
        <pc:sldMkLst>
          <pc:docMk/>
          <pc:sldMk cId="3959166534" sldId="283"/>
        </pc:sldMkLst>
      </pc:sldChg>
    </pc:docChg>
  </pc:docChgLst>
  <pc:docChgLst>
    <pc:chgData clId="Web-{2078CF52-1543-3A94-1FF6-FDE5A1C808B6}"/>
    <pc:docChg chg="addSld">
      <pc:chgData name="" userId="" providerId="" clId="Web-{2078CF52-1543-3A94-1FF6-FDE5A1C808B6}" dt="2025-07-25T12:42:52.619" v="0"/>
      <pc:docMkLst>
        <pc:docMk/>
      </pc:docMkLst>
      <pc:sldChg chg="add replId">
        <pc:chgData name="" userId="" providerId="" clId="Web-{2078CF52-1543-3A94-1FF6-FDE5A1C808B6}" dt="2025-07-25T12:42:52.619" v="0"/>
        <pc:sldMkLst>
          <pc:docMk/>
          <pc:sldMk cId="3846821981" sldId="297"/>
        </pc:sldMkLst>
      </pc:sldChg>
    </pc:docChg>
  </pc:docChgLst>
  <pc:docChgLst>
    <pc:chgData name="Míriam Fernández González" userId="352a0393-308e-4058-8495-78b481706071" providerId="ADAL" clId="{6CC23B6F-D564-426D-940C-C35F10A92CC4}"/>
    <pc:docChg chg="undo custSel addSld delSld modSld sldOrd">
      <pc:chgData name="Míriam Fernández González" userId="352a0393-308e-4058-8495-78b481706071" providerId="ADAL" clId="{6CC23B6F-D564-426D-940C-C35F10A92CC4}" dt="2025-07-25T13:42:06.046" v="1944" actId="20577"/>
      <pc:docMkLst>
        <pc:docMk/>
      </pc:docMkLst>
      <pc:sldChg chg="del">
        <pc:chgData name="Míriam Fernández González" userId="352a0393-308e-4058-8495-78b481706071" providerId="ADAL" clId="{6CC23B6F-D564-426D-940C-C35F10A92CC4}" dt="2025-07-23T10:06:54.583" v="1" actId="47"/>
        <pc:sldMkLst>
          <pc:docMk/>
          <pc:sldMk cId="2406273178" sldId="256"/>
        </pc:sldMkLst>
      </pc:sldChg>
      <pc:sldChg chg="addSp delSp modSp new mod">
        <pc:chgData name="Míriam Fernández González" userId="352a0393-308e-4058-8495-78b481706071" providerId="ADAL" clId="{6CC23B6F-D564-426D-940C-C35F10A92CC4}" dt="2025-07-25T12:48:25.066" v="1673" actId="1076"/>
        <pc:sldMkLst>
          <pc:docMk/>
          <pc:sldMk cId="1899656772" sldId="257"/>
        </pc:sldMkLst>
      </pc:sldChg>
      <pc:sldChg chg="add del">
        <pc:chgData name="Míriam Fernández González" userId="352a0393-308e-4058-8495-78b481706071" providerId="ADAL" clId="{6CC23B6F-D564-426D-940C-C35F10A92CC4}" dt="2025-07-23T10:08:25.607" v="29" actId="47"/>
        <pc:sldMkLst>
          <pc:docMk/>
          <pc:sldMk cId="4080752078" sldId="258"/>
        </pc:sldMkLst>
      </pc:sldChg>
      <pc:sldChg chg="add del">
        <pc:chgData name="Míriam Fernández González" userId="352a0393-308e-4058-8495-78b481706071" providerId="ADAL" clId="{6CC23B6F-D564-426D-940C-C35F10A92CC4}" dt="2025-07-23T10:08:26.158" v="30" actId="47"/>
        <pc:sldMkLst>
          <pc:docMk/>
          <pc:sldMk cId="3580857271" sldId="259"/>
        </pc:sldMkLst>
      </pc:sldChg>
      <pc:sldChg chg="add del">
        <pc:chgData name="Míriam Fernández González" userId="352a0393-308e-4058-8495-78b481706071" providerId="ADAL" clId="{6CC23B6F-D564-426D-940C-C35F10A92CC4}" dt="2025-07-23T10:08:26.661" v="31" actId="47"/>
        <pc:sldMkLst>
          <pc:docMk/>
          <pc:sldMk cId="2234829343" sldId="260"/>
        </pc:sldMkLst>
      </pc:sldChg>
      <pc:sldChg chg="add del">
        <pc:chgData name="Míriam Fernández González" userId="352a0393-308e-4058-8495-78b481706071" providerId="ADAL" clId="{6CC23B6F-D564-426D-940C-C35F10A92CC4}" dt="2025-07-23T10:08:26.959" v="32" actId="47"/>
        <pc:sldMkLst>
          <pc:docMk/>
          <pc:sldMk cId="862921727" sldId="261"/>
        </pc:sldMkLst>
      </pc:sldChg>
      <pc:sldChg chg="add del">
        <pc:chgData name="Míriam Fernández González" userId="352a0393-308e-4058-8495-78b481706071" providerId="ADAL" clId="{6CC23B6F-D564-426D-940C-C35F10A92CC4}" dt="2025-07-23T10:08:27.211" v="33" actId="47"/>
        <pc:sldMkLst>
          <pc:docMk/>
          <pc:sldMk cId="3804607996" sldId="262"/>
        </pc:sldMkLst>
      </pc:sldChg>
      <pc:sldChg chg="add del">
        <pc:chgData name="Míriam Fernández González" userId="352a0393-308e-4058-8495-78b481706071" providerId="ADAL" clId="{6CC23B6F-D564-426D-940C-C35F10A92CC4}" dt="2025-07-23T10:08:27.431" v="34" actId="47"/>
        <pc:sldMkLst>
          <pc:docMk/>
          <pc:sldMk cId="4226813653" sldId="263"/>
        </pc:sldMkLst>
      </pc:sldChg>
      <pc:sldChg chg="add del">
        <pc:chgData name="Míriam Fernández González" userId="352a0393-308e-4058-8495-78b481706071" providerId="ADAL" clId="{6CC23B6F-D564-426D-940C-C35F10A92CC4}" dt="2025-07-23T10:08:27.626" v="35" actId="47"/>
        <pc:sldMkLst>
          <pc:docMk/>
          <pc:sldMk cId="1753621800" sldId="264"/>
        </pc:sldMkLst>
      </pc:sldChg>
      <pc:sldChg chg="add del">
        <pc:chgData name="Míriam Fernández González" userId="352a0393-308e-4058-8495-78b481706071" providerId="ADAL" clId="{6CC23B6F-D564-426D-940C-C35F10A92CC4}" dt="2025-07-23T10:08:27.807" v="36" actId="47"/>
        <pc:sldMkLst>
          <pc:docMk/>
          <pc:sldMk cId="3900698960" sldId="265"/>
        </pc:sldMkLst>
      </pc:sldChg>
      <pc:sldChg chg="add del">
        <pc:chgData name="Míriam Fernández González" userId="352a0393-308e-4058-8495-78b481706071" providerId="ADAL" clId="{6CC23B6F-D564-426D-940C-C35F10A92CC4}" dt="2025-07-23T10:08:27.980" v="37" actId="47"/>
        <pc:sldMkLst>
          <pc:docMk/>
          <pc:sldMk cId="2255315707" sldId="266"/>
        </pc:sldMkLst>
      </pc:sldChg>
      <pc:sldChg chg="add del">
        <pc:chgData name="Míriam Fernández González" userId="352a0393-308e-4058-8495-78b481706071" providerId="ADAL" clId="{6CC23B6F-D564-426D-940C-C35F10A92CC4}" dt="2025-07-23T10:08:28.184" v="38" actId="47"/>
        <pc:sldMkLst>
          <pc:docMk/>
          <pc:sldMk cId="1476492493" sldId="267"/>
        </pc:sldMkLst>
      </pc:sldChg>
      <pc:sldChg chg="add del">
        <pc:chgData name="Míriam Fernández González" userId="352a0393-308e-4058-8495-78b481706071" providerId="ADAL" clId="{6CC23B6F-D564-426D-940C-C35F10A92CC4}" dt="2025-07-23T10:08:28.466" v="39" actId="47"/>
        <pc:sldMkLst>
          <pc:docMk/>
          <pc:sldMk cId="835741156" sldId="268"/>
        </pc:sldMkLst>
      </pc:sldChg>
      <pc:sldChg chg="add del">
        <pc:chgData name="Míriam Fernández González" userId="352a0393-308e-4058-8495-78b481706071" providerId="ADAL" clId="{6CC23B6F-D564-426D-940C-C35F10A92CC4}" dt="2025-07-23T10:08:29.142" v="40" actId="47"/>
        <pc:sldMkLst>
          <pc:docMk/>
          <pc:sldMk cId="1533935708" sldId="269"/>
        </pc:sldMkLst>
      </pc:sldChg>
      <pc:sldChg chg="add del ord">
        <pc:chgData name="Míriam Fernández González" userId="352a0393-308e-4058-8495-78b481706071" providerId="ADAL" clId="{6CC23B6F-D564-426D-940C-C35F10A92CC4}" dt="2025-07-23T10:08:22.656" v="28" actId="47"/>
        <pc:sldMkLst>
          <pc:docMk/>
          <pc:sldMk cId="3361930825" sldId="270"/>
        </pc:sldMkLst>
      </pc:sldChg>
      <pc:sldChg chg="add del">
        <pc:chgData name="Míriam Fernández González" userId="352a0393-308e-4058-8495-78b481706071" providerId="ADAL" clId="{6CC23B6F-D564-426D-940C-C35F10A92CC4}" dt="2025-07-23T10:08:18.413" v="25" actId="47"/>
        <pc:sldMkLst>
          <pc:docMk/>
          <pc:sldMk cId="234280666" sldId="271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8:24.392" v="1505" actId="1076"/>
        <pc:sldMkLst>
          <pc:docMk/>
          <pc:sldMk cId="2286362297" sldId="272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05.490" v="402" actId="1076"/>
        <pc:sldMkLst>
          <pc:docMk/>
          <pc:sldMk cId="3604231316" sldId="273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37.465" v="407" actId="1076"/>
        <pc:sldMkLst>
          <pc:docMk/>
          <pc:sldMk cId="2525473906" sldId="274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9:09.219" v="1514" actId="1076"/>
        <pc:sldMkLst>
          <pc:docMk/>
          <pc:sldMk cId="98097563" sldId="275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42:06.046" v="1944" actId="20577"/>
        <pc:sldMkLst>
          <pc:docMk/>
          <pc:sldMk cId="849156004" sldId="276"/>
        </pc:sldMkLst>
      </pc:sldChg>
      <pc:sldChg chg="addSp modSp add mod ord">
        <pc:chgData name="Míriam Fernández González" userId="352a0393-308e-4058-8495-78b481706071" providerId="ADAL" clId="{6CC23B6F-D564-426D-940C-C35F10A92CC4}" dt="2025-07-23T15:10:13.896" v="1530" actId="732"/>
        <pc:sldMkLst>
          <pc:docMk/>
          <pc:sldMk cId="631989269" sldId="277"/>
        </pc:sldMkLst>
      </pc:sldChg>
      <pc:sldChg chg="add del">
        <pc:chgData name="Míriam Fernández González" userId="352a0393-308e-4058-8495-78b481706071" providerId="ADAL" clId="{6CC23B6F-D564-426D-940C-C35F10A92CC4}" dt="2025-07-23T10:28:22.542" v="472" actId="47"/>
        <pc:sldMkLst>
          <pc:docMk/>
          <pc:sldMk cId="1700075419" sldId="27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6:16.325" v="1797" actId="1076"/>
        <pc:sldMkLst>
          <pc:docMk/>
          <pc:sldMk cId="989154112" sldId="278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5:38.084" v="1784" actId="1076"/>
        <pc:sldMkLst>
          <pc:docMk/>
          <pc:sldMk cId="1574192415" sldId="279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03.884" v="1543" actId="1076"/>
        <pc:sldMkLst>
          <pc:docMk/>
          <pc:sldMk cId="3766750973" sldId="280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18.375" v="1546" actId="1076"/>
        <pc:sldMkLst>
          <pc:docMk/>
          <pc:sldMk cId="3324629129" sldId="28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8:08.500" v="1887" actId="1076"/>
        <pc:sldMkLst>
          <pc:docMk/>
          <pc:sldMk cId="2685193683" sldId="282"/>
        </pc:sldMkLst>
      </pc:sldChg>
      <pc:sldChg chg="add del">
        <pc:chgData name="Míriam Fernández González" userId="352a0393-308e-4058-8495-78b481706071" providerId="ADAL" clId="{6CC23B6F-D564-426D-940C-C35F10A92CC4}" dt="2025-07-23T10:40:15.154" v="784" actId="47"/>
        <pc:sldMkLst>
          <pc:docMk/>
          <pc:sldMk cId="3650244235" sldId="282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38:50.567" v="1898" actId="14100"/>
        <pc:sldMkLst>
          <pc:docMk/>
          <pc:sldMk cId="3959166534" sldId="28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6:28.343" v="1488" actId="1076"/>
        <pc:sldMkLst>
          <pc:docMk/>
          <pc:sldMk cId="640523941" sldId="284"/>
        </pc:sldMkLst>
      </pc:sldChg>
      <pc:sldChg chg="addSp delSp modSp add del mod">
        <pc:chgData name="Míriam Fernández González" userId="352a0393-308e-4058-8495-78b481706071" providerId="ADAL" clId="{6CC23B6F-D564-426D-940C-C35F10A92CC4}" dt="2025-07-23T11:07:57.119" v="1087" actId="47"/>
        <pc:sldMkLst>
          <pc:docMk/>
          <pc:sldMk cId="2552082302" sldId="285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15.365" v="1494" actId="1076"/>
        <pc:sldMkLst>
          <pc:docMk/>
          <pc:sldMk cId="2388881966" sldId="286"/>
        </pc:sldMkLst>
      </pc:sldChg>
      <pc:sldChg chg="delSp modSp add del mod">
        <pc:chgData name="Míriam Fernández González" userId="352a0393-308e-4058-8495-78b481706071" providerId="ADAL" clId="{6CC23B6F-D564-426D-940C-C35F10A92CC4}" dt="2025-07-23T11:09:33.386" v="1121" actId="47"/>
        <pc:sldMkLst>
          <pc:docMk/>
          <pc:sldMk cId="872468030" sldId="28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6:34.939" v="1490" actId="1076"/>
        <pc:sldMkLst>
          <pc:docMk/>
          <pc:sldMk cId="1854992774" sldId="288"/>
        </pc:sldMkLst>
      </pc:sldChg>
      <pc:sldChg chg="delSp modSp add del mod">
        <pc:chgData name="Míriam Fernández González" userId="352a0393-308e-4058-8495-78b481706071" providerId="ADAL" clId="{6CC23B6F-D564-426D-940C-C35F10A92CC4}" dt="2025-07-23T14:58:21.220" v="1349" actId="47"/>
        <pc:sldMkLst>
          <pc:docMk/>
          <pc:sldMk cId="944466747" sldId="289"/>
        </pc:sldMkLst>
      </pc:sldChg>
      <pc:sldChg chg="delSp modSp add del mod">
        <pc:chgData name="Míriam Fernández González" userId="352a0393-308e-4058-8495-78b481706071" providerId="ADAL" clId="{6CC23B6F-D564-426D-940C-C35F10A92CC4}" dt="2025-07-23T11:17:00.464" v="1307" actId="47"/>
        <pc:sldMkLst>
          <pc:docMk/>
          <pc:sldMk cId="699899518" sldId="290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42.025" v="1498" actId="14100"/>
        <pc:sldMkLst>
          <pc:docMk/>
          <pc:sldMk cId="3714277399" sldId="29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7:55.238" v="1499"/>
        <pc:sldMkLst>
          <pc:docMk/>
          <pc:sldMk cId="3491293808" sldId="292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26.903" v="1496" actId="1076"/>
        <pc:sldMkLst>
          <pc:docMk/>
          <pc:sldMk cId="1938919551" sldId="29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57.744" v="1500"/>
        <pc:sldMkLst>
          <pc:docMk/>
          <pc:sldMk cId="2278150265" sldId="294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08.012" v="1501"/>
        <pc:sldMkLst>
          <pc:docMk/>
          <pc:sldMk cId="3333836771" sldId="295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10.319" v="1502"/>
        <pc:sldMkLst>
          <pc:docMk/>
          <pc:sldMk cId="3104352323" sldId="296"/>
        </pc:sldMkLst>
      </pc:sldChg>
      <pc:sldChg chg="addSp delSp modSp new del mod">
        <pc:chgData name="Míriam Fernández González" userId="352a0393-308e-4058-8495-78b481706071" providerId="ADAL" clId="{6CC23B6F-D564-426D-940C-C35F10A92CC4}" dt="2025-07-23T15:02:36.537" v="1431" actId="47"/>
        <pc:sldMkLst>
          <pc:docMk/>
          <pc:sldMk cId="479128856" sldId="297"/>
        </pc:sldMkLst>
      </pc:sldChg>
      <pc:sldChg chg="addSp modSp mod">
        <pc:chgData name="Míriam Fernández González" userId="352a0393-308e-4058-8495-78b481706071" providerId="ADAL" clId="{6CC23B6F-D564-426D-940C-C35F10A92CC4}" dt="2025-07-25T12:48:07.213" v="1669" actId="1076"/>
        <pc:sldMkLst>
          <pc:docMk/>
          <pc:sldMk cId="3846821981" sldId="297"/>
        </pc:sldMkLst>
      </pc:sldChg>
      <pc:sldChg chg="addSp delSp modSp mod">
        <pc:chgData name="Míriam Fernández González" userId="352a0393-308e-4058-8495-78b481706071" providerId="ADAL" clId="{6CC23B6F-D564-426D-940C-C35F10A92CC4}" dt="2025-07-25T12:48:34.066" v="1678" actId="1036"/>
        <pc:sldMkLst>
          <pc:docMk/>
          <pc:sldMk cId="3507912059" sldId="298"/>
        </pc:sldMkLst>
      </pc:sldChg>
      <pc:sldChg chg="addSp delSp modSp mod">
        <pc:chgData name="Míriam Fernández González" userId="352a0393-308e-4058-8495-78b481706071" providerId="ADAL" clId="{6CC23B6F-D564-426D-940C-C35F10A92CC4}" dt="2025-07-25T13:39:30.415" v="1907" actId="1076"/>
        <pc:sldMkLst>
          <pc:docMk/>
          <pc:sldMk cId="1510078259" sldId="299"/>
        </pc:sldMkLst>
      </pc:sldChg>
      <pc:sldChg chg="addSp delSp modSp mod">
        <pc:chgData name="Míriam Fernández González" userId="352a0393-308e-4058-8495-78b481706071" providerId="ADAL" clId="{6CC23B6F-D564-426D-940C-C35F10A92CC4}" dt="2025-07-25T13:40:05.751" v="1930" actId="1036"/>
        <pc:sldMkLst>
          <pc:docMk/>
          <pc:sldMk cId="1256841142" sldId="300"/>
        </pc:sldMkLst>
      </pc:sldChg>
      <pc:sldChg chg="modSp mod">
        <pc:chgData name="Míriam Fernández González" userId="352a0393-308e-4058-8495-78b481706071" providerId="ADAL" clId="{6CC23B6F-D564-426D-940C-C35F10A92CC4}" dt="2025-07-25T13:33:06.576" v="1682" actId="20577"/>
        <pc:sldMkLst>
          <pc:docMk/>
          <pc:sldMk cId="1296663075" sldId="301"/>
        </pc:sldMkLst>
      </pc:sldChg>
      <pc:sldChg chg="modSp mod">
        <pc:chgData name="Míriam Fernández González" userId="352a0393-308e-4058-8495-78b481706071" providerId="ADAL" clId="{6CC23B6F-D564-426D-940C-C35F10A92CC4}" dt="2025-07-25T13:33:37.413" v="1694" actId="20577"/>
        <pc:sldMkLst>
          <pc:docMk/>
          <pc:sldMk cId="2571517090" sldId="302"/>
        </pc:sldMkLst>
      </pc:sldChg>
      <pc:sldChg chg="modSp mod">
        <pc:chgData name="Míriam Fernández González" userId="352a0393-308e-4058-8495-78b481706071" providerId="ADAL" clId="{6CC23B6F-D564-426D-940C-C35F10A92CC4}" dt="2025-07-25T13:33:26.110" v="1690" actId="20577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98EE4D30-4875-04A6-BF8A-D2A056950045}"/>
    <pc:docChg chg="modSld">
      <pc:chgData name="Míriam Fernández González" userId="S::mfernandez@idibell.cat::352a0393-308e-4058-8495-78b481706071" providerId="AD" clId="Web-{98EE4D30-4875-04A6-BF8A-D2A056950045}" dt="2025-07-25T13:30:24.917" v="14" actId="1076"/>
      <pc:docMkLst>
        <pc:docMk/>
      </pc:docMkLst>
      <pc:sldChg chg="modSp">
        <pc:chgData name="Míriam Fernández González" userId="S::mfernandez@idibell.cat::352a0393-308e-4058-8495-78b481706071" providerId="AD" clId="Web-{98EE4D30-4875-04A6-BF8A-D2A056950045}" dt="2025-07-25T12:54:33.628" v="0" actId="1076"/>
        <pc:sldMkLst>
          <pc:docMk/>
          <pc:sldMk cId="3604231316" sldId="273"/>
        </pc:sldMkLst>
      </pc:sldChg>
      <pc:sldChg chg="addSp delSp modSp">
        <pc:chgData name="Míriam Fernández González" userId="S::mfernandez@idibell.cat::352a0393-308e-4058-8495-78b481706071" providerId="AD" clId="Web-{98EE4D30-4875-04A6-BF8A-D2A056950045}" dt="2025-07-25T13:30:24.917" v="14" actId="1076"/>
        <pc:sldMkLst>
          <pc:docMk/>
          <pc:sldMk cId="2685193683" sldId="282"/>
        </pc:sldMkLst>
      </pc:sldChg>
    </pc:docChg>
  </pc:docChgLst>
  <pc:docChgLst>
    <pc:chgData name="Jacopo Boni" userId="3468928e-f576-476d-811b-ea8091bad45a" providerId="ADAL" clId="{F8328929-8069-4A27-BC10-04899D47FBC5}"/>
    <pc:docChg chg="delSld">
      <pc:chgData name="Jacopo Boni" userId="3468928e-f576-476d-811b-ea8091bad45a" providerId="ADAL" clId="{F8328929-8069-4A27-BC10-04899D47FBC5}" dt="2025-09-08T15:14:01.713" v="3" actId="47"/>
      <pc:docMkLst>
        <pc:docMk/>
      </pc:docMkLst>
      <pc:sldChg chg="del">
        <pc:chgData name="Jacopo Boni" userId="3468928e-f576-476d-811b-ea8091bad45a" providerId="ADAL" clId="{F8328929-8069-4A27-BC10-04899D47FBC5}" dt="2025-09-08T15:13:46.544" v="2" actId="47"/>
        <pc:sldMkLst>
          <pc:docMk/>
          <pc:sldMk cId="1899656772" sldId="257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631989269" sldId="277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989154112" sldId="278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1574192415" sldId="279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3766750973" sldId="280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3324629129" sldId="281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2685193683" sldId="282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3959166534" sldId="283"/>
        </pc:sldMkLst>
      </pc:sldChg>
      <pc:sldChg chg="del">
        <pc:chgData name="Jacopo Boni" userId="3468928e-f576-476d-811b-ea8091bad45a" providerId="ADAL" clId="{F8328929-8069-4A27-BC10-04899D47FBC5}" dt="2025-09-08T15:13:44.471" v="0" actId="47"/>
        <pc:sldMkLst>
          <pc:docMk/>
          <pc:sldMk cId="3846821981" sldId="297"/>
        </pc:sldMkLst>
      </pc:sldChg>
      <pc:sldChg chg="del">
        <pc:chgData name="Jacopo Boni" userId="3468928e-f576-476d-811b-ea8091bad45a" providerId="ADAL" clId="{F8328929-8069-4A27-BC10-04899D47FBC5}" dt="2025-09-08T15:13:45.077" v="1" actId="47"/>
        <pc:sldMkLst>
          <pc:docMk/>
          <pc:sldMk cId="3507912059" sldId="298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1510078259" sldId="299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1256841142" sldId="300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1296663075" sldId="301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2571517090" sldId="302"/>
        </pc:sldMkLst>
      </pc:sldChg>
      <pc:sldChg chg="del">
        <pc:chgData name="Jacopo Boni" userId="3468928e-f576-476d-811b-ea8091bad45a" providerId="ADAL" clId="{F8328929-8069-4A27-BC10-04899D47FBC5}" dt="2025-09-08T15:14:01.713" v="3" actId="47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2078CF52-1543-3A94-1FF6-FDE5A1C808B6}"/>
    <pc:docChg chg="addSld modSld sldOrd">
      <pc:chgData name="Míriam Fernández González" userId="S::mfernandez@idibell.cat::352a0393-308e-4058-8495-78b481706071" providerId="AD" clId="Web-{2078CF52-1543-3A94-1FF6-FDE5A1C808B6}" dt="2025-07-25T12:43:24.933" v="2"/>
      <pc:docMkLst>
        <pc:docMk/>
      </pc:docMkLst>
      <pc:sldChg chg="addSp modSp ord">
        <pc:chgData name="Míriam Fernández González" userId="S::mfernandez@idibell.cat::352a0393-308e-4058-8495-78b481706071" providerId="AD" clId="Web-{2078CF52-1543-3A94-1FF6-FDE5A1C808B6}" dt="2025-07-25T12:43:24.933" v="2"/>
        <pc:sldMkLst>
          <pc:docMk/>
          <pc:sldMk cId="1899656772" sldId="257"/>
        </pc:sldMkLst>
      </pc:sldChg>
      <pc:sldChg chg="add replId">
        <pc:chgData name="Míriam Fernández González" userId="S::mfernandez@idibell.cat::352a0393-308e-4058-8495-78b481706071" providerId="AD" clId="Web-{2078CF52-1543-3A94-1FF6-FDE5A1C808B6}" dt="2025-07-25T12:42:53.666" v="0"/>
        <pc:sldMkLst>
          <pc:docMk/>
          <pc:sldMk cId="3507912059" sldId="29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8191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1863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5096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174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9700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9029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394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0658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2375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044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03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3118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19CCEF-7ED3-AAB0-F97F-CCCF247008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Imagen 41" descr="Imagen que contiene nieve, refrigerador, cubierto, estufa&#10;&#10;El contenido generado por IA puede ser incorrecto.">
            <a:extLst>
              <a:ext uri="{FF2B5EF4-FFF2-40B4-BE49-F238E27FC236}">
                <a16:creationId xmlns:a16="http://schemas.microsoft.com/office/drawing/2014/main" id="{39B94FED-B609-43DB-88D0-C8A0B44640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7815" y="1413029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A3C6A6FB-0700-51F6-70CD-031EF363CBD5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4FEBFE61-C0A9-2952-F0D2-D7BC41D7F612}"/>
              </a:ext>
            </a:extLst>
          </p:cNvPr>
          <p:cNvSpPr/>
          <p:nvPr/>
        </p:nvSpPr>
        <p:spPr>
          <a:xfrm>
            <a:off x="3330331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35AB8624-636A-91AA-9ADD-92CE70D2F582}"/>
              </a:ext>
            </a:extLst>
          </p:cNvPr>
          <p:cNvSpPr txBox="1"/>
          <p:nvPr/>
        </p:nvSpPr>
        <p:spPr>
          <a:xfrm rot="16200000">
            <a:off x="5350409" y="-1043463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F7C5944C-B579-E5C5-0726-8189483CEE38}"/>
              </a:ext>
            </a:extLst>
          </p:cNvPr>
          <p:cNvSpPr txBox="1"/>
          <p:nvPr/>
        </p:nvSpPr>
        <p:spPr>
          <a:xfrm>
            <a:off x="9419953" y="2635559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082C9C79-4226-D4C0-B5C1-77F5F3D95FB4}"/>
              </a:ext>
            </a:extLst>
          </p:cNvPr>
          <p:cNvSpPr/>
          <p:nvPr/>
        </p:nvSpPr>
        <p:spPr>
          <a:xfrm>
            <a:off x="5937848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3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1ED9B851-B495-79EB-BE01-101A92F5A6C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1279523" y="2223824"/>
            <a:ext cx="1806927" cy="17669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405239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44AE30-7312-1A9A-48C3-2D39AB26B6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3EF605B1-5660-826B-4006-3E20286D5ECF}"/>
              </a:ext>
            </a:extLst>
          </p:cNvPr>
          <p:cNvSpPr txBox="1"/>
          <p:nvPr/>
        </p:nvSpPr>
        <p:spPr>
          <a:xfrm>
            <a:off x="370936" y="336430"/>
            <a:ext cx="43633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E</a:t>
            </a:r>
          </a:p>
        </p:txBody>
      </p:sp>
      <p:pic>
        <p:nvPicPr>
          <p:cNvPr id="17" name="Imagen 16" descr="Imagen que contiene interior, horno, abrir, puerta&#10;&#10;El contenido generado por IA puede ser incorrecto.">
            <a:extLst>
              <a:ext uri="{FF2B5EF4-FFF2-40B4-BE49-F238E27FC236}">
                <a16:creationId xmlns:a16="http://schemas.microsoft.com/office/drawing/2014/main" id="{EA5E1588-8AAE-94D2-C25C-9FFD94E50D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5322" y="1027198"/>
            <a:ext cx="7047690" cy="5125592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id="{411E466C-C29D-1346-CAED-91137D8E0BED}"/>
              </a:ext>
            </a:extLst>
          </p:cNvPr>
          <p:cNvSpPr/>
          <p:nvPr/>
        </p:nvSpPr>
        <p:spPr>
          <a:xfrm>
            <a:off x="4830792" y="2165230"/>
            <a:ext cx="3071004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56EB213B-80CF-C111-DB3D-C45E7C2C5985}"/>
              </a:ext>
            </a:extLst>
          </p:cNvPr>
          <p:cNvSpPr/>
          <p:nvPr/>
        </p:nvSpPr>
        <p:spPr>
          <a:xfrm>
            <a:off x="4500112" y="3749615"/>
            <a:ext cx="3151517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AB9CAD50-6D1D-4C4C-1433-D34336938467}"/>
              </a:ext>
            </a:extLst>
          </p:cNvPr>
          <p:cNvSpPr txBox="1"/>
          <p:nvPr/>
        </p:nvSpPr>
        <p:spPr>
          <a:xfrm>
            <a:off x="9523563" y="2273862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A972CB6C-2DBF-9DA0-0D87-123B487BB8A3}"/>
              </a:ext>
            </a:extLst>
          </p:cNvPr>
          <p:cNvSpPr txBox="1"/>
          <p:nvPr/>
        </p:nvSpPr>
        <p:spPr>
          <a:xfrm>
            <a:off x="9213012" y="3966879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1449D1B-E579-C127-EE95-19F100418F24}"/>
              </a:ext>
            </a:extLst>
          </p:cNvPr>
          <p:cNvSpPr txBox="1"/>
          <p:nvPr/>
        </p:nvSpPr>
        <p:spPr>
          <a:xfrm rot="16200000">
            <a:off x="5887527" y="214034"/>
            <a:ext cx="100929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K656E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+)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E656744E-D219-DC35-721B-FDD42B7B5CC9}"/>
              </a:ext>
            </a:extLst>
          </p:cNvPr>
          <p:cNvSpPr txBox="1"/>
          <p:nvPr/>
        </p:nvSpPr>
        <p:spPr>
          <a:xfrm rot="16200000">
            <a:off x="5591354" y="3293304"/>
            <a:ext cx="100929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WT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WT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+)</a:t>
            </a:r>
          </a:p>
        </p:txBody>
      </p:sp>
      <p:pic>
        <p:nvPicPr>
          <p:cNvPr id="1026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1B1768B3-C185-E947-BA0D-A6970A3F3FD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2695906" y="3621602"/>
            <a:ext cx="1254991" cy="12272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A96C4396-DF33-ED83-6263-5D77E6EF4F6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8343333" y="2029588"/>
            <a:ext cx="1254991" cy="12272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863622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BAEAEA-646B-3B3D-1376-22006649A5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 descr="Imagen que contiene interior, camioneta, tabla, hombre&#10;&#10;El contenido generado por IA puede ser incorrecto.">
            <a:extLst>
              <a:ext uri="{FF2B5EF4-FFF2-40B4-BE49-F238E27FC236}">
                <a16:creationId xmlns:a16="http://schemas.microsoft.com/office/drawing/2014/main" id="{0ABB2BA8-89CE-36E2-ECD0-A1C90A03C6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1917" y="865799"/>
            <a:ext cx="7048800" cy="512640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F3D2419D-2E13-9923-C4A3-31917FFDA478}"/>
              </a:ext>
            </a:extLst>
          </p:cNvPr>
          <p:cNvSpPr txBox="1"/>
          <p:nvPr/>
        </p:nvSpPr>
        <p:spPr>
          <a:xfrm>
            <a:off x="370936" y="336430"/>
            <a:ext cx="43633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E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4E4158FE-3441-7A57-5D30-44E216835B31}"/>
              </a:ext>
            </a:extLst>
          </p:cNvPr>
          <p:cNvSpPr/>
          <p:nvPr/>
        </p:nvSpPr>
        <p:spPr>
          <a:xfrm>
            <a:off x="5310995" y="2232590"/>
            <a:ext cx="3151517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AAB0B2D1-9562-B8FC-ACA6-680DFD5C28FF}"/>
              </a:ext>
            </a:extLst>
          </p:cNvPr>
          <p:cNvSpPr txBox="1"/>
          <p:nvPr/>
        </p:nvSpPr>
        <p:spPr>
          <a:xfrm rot="16200000">
            <a:off x="6560153" y="173672"/>
            <a:ext cx="1009291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WT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WT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+)</a:t>
            </a:r>
          </a:p>
        </p:txBody>
      </p:sp>
      <p:pic>
        <p:nvPicPr>
          <p:cNvPr id="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22D72284-5732-269F-D908-A6290D5E74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3608554" y="2137859"/>
            <a:ext cx="1254991" cy="12272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1B60A062-19FA-EB59-B3F0-5686F3A0EBFF}"/>
              </a:ext>
            </a:extLst>
          </p:cNvPr>
          <p:cNvSpPr txBox="1"/>
          <p:nvPr/>
        </p:nvSpPr>
        <p:spPr>
          <a:xfrm>
            <a:off x="9800717" y="2341222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pFGFR1</a:t>
            </a:r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78AD2136-BDF1-46EF-0AC0-30056592981C}"/>
              </a:ext>
            </a:extLst>
          </p:cNvPr>
          <p:cNvSpPr/>
          <p:nvPr/>
        </p:nvSpPr>
        <p:spPr>
          <a:xfrm>
            <a:off x="5385757" y="3987059"/>
            <a:ext cx="3151517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89160820-3BC8-6F90-DA0B-42372928FD1D}"/>
              </a:ext>
            </a:extLst>
          </p:cNvPr>
          <p:cNvSpPr txBox="1"/>
          <p:nvPr/>
        </p:nvSpPr>
        <p:spPr>
          <a:xfrm>
            <a:off x="9800717" y="4095691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err="1">
                <a:solidFill>
                  <a:srgbClr val="FF0000"/>
                </a:solidFill>
              </a:rPr>
              <a:t>pERK</a:t>
            </a:r>
            <a:endParaRPr lang="en-US" b="1">
              <a:solidFill>
                <a:srgbClr val="FF0000"/>
              </a:solidFill>
            </a:endParaRPr>
          </a:p>
        </p:txBody>
      </p:sp>
      <p:pic>
        <p:nvPicPr>
          <p:cNvPr id="16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7A8E1365-8853-29C3-E759-87609179E58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7966" r="34356" b="32726"/>
          <a:stretch>
            <a:fillRect/>
          </a:stretch>
        </p:blipFill>
        <p:spPr bwMode="auto">
          <a:xfrm>
            <a:off x="2731434" y="3642236"/>
            <a:ext cx="2122085" cy="16455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042313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CD5EB6-52F8-8F84-0C1F-5EEA002E99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F0063947-5632-B8E1-981C-0326209F5DF3}"/>
              </a:ext>
            </a:extLst>
          </p:cNvPr>
          <p:cNvSpPr txBox="1"/>
          <p:nvPr/>
        </p:nvSpPr>
        <p:spPr>
          <a:xfrm>
            <a:off x="370936" y="336430"/>
            <a:ext cx="43633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E</a:t>
            </a:r>
          </a:p>
        </p:txBody>
      </p:sp>
      <p:pic>
        <p:nvPicPr>
          <p:cNvPr id="9" name="Imagen 8" descr="Imagen que contiene interior, camioneta, tabla, llenado&#10;&#10;El contenido generado por IA puede ser incorrecto.">
            <a:extLst>
              <a:ext uri="{FF2B5EF4-FFF2-40B4-BE49-F238E27FC236}">
                <a16:creationId xmlns:a16="http://schemas.microsoft.com/office/drawing/2014/main" id="{3C82C504-5D34-4AFA-EA1B-D5288F25BE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3895" y="810818"/>
            <a:ext cx="7200000" cy="5236364"/>
          </a:xfrm>
          <a:prstGeom prst="rect">
            <a:avLst/>
          </a:prstGeom>
        </p:spPr>
      </p:pic>
      <p:sp>
        <p:nvSpPr>
          <p:cNvPr id="3" name="Rectángulo 2">
            <a:extLst>
              <a:ext uri="{FF2B5EF4-FFF2-40B4-BE49-F238E27FC236}">
                <a16:creationId xmlns:a16="http://schemas.microsoft.com/office/drawing/2014/main" id="{AF4931FC-2E8E-3274-2738-B18ED1FF67FE}"/>
              </a:ext>
            </a:extLst>
          </p:cNvPr>
          <p:cNvSpPr/>
          <p:nvPr/>
        </p:nvSpPr>
        <p:spPr>
          <a:xfrm>
            <a:off x="5253488" y="1680549"/>
            <a:ext cx="3071004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9D7D3605-D2EB-EE2B-D85D-EC7217CA17DF}"/>
              </a:ext>
            </a:extLst>
          </p:cNvPr>
          <p:cNvSpPr txBox="1"/>
          <p:nvPr/>
        </p:nvSpPr>
        <p:spPr>
          <a:xfrm rot="16200000">
            <a:off x="6310223" y="-270647"/>
            <a:ext cx="100929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K656E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+)</a:t>
            </a:r>
          </a:p>
        </p:txBody>
      </p:sp>
      <p:pic>
        <p:nvPicPr>
          <p:cNvPr id="5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E6F834D6-5B91-6136-09B0-C19AB7D5EA0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8855718" y="1360241"/>
            <a:ext cx="1254991" cy="12272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007634F3-142F-4D62-EE47-9A27EF4D6D0D}"/>
              </a:ext>
            </a:extLst>
          </p:cNvPr>
          <p:cNvSpPr txBox="1"/>
          <p:nvPr/>
        </p:nvSpPr>
        <p:spPr>
          <a:xfrm>
            <a:off x="10205287" y="1789180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pFGFR1</a:t>
            </a: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60814CFF-5B67-B324-D1F6-BD2C3B2297F9}"/>
              </a:ext>
            </a:extLst>
          </p:cNvPr>
          <p:cNvSpPr/>
          <p:nvPr/>
        </p:nvSpPr>
        <p:spPr>
          <a:xfrm>
            <a:off x="5518030" y="3394496"/>
            <a:ext cx="3177395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12552B12-FAA4-8408-212C-3FB78FB7D1E2}"/>
              </a:ext>
            </a:extLst>
          </p:cNvPr>
          <p:cNvSpPr txBox="1"/>
          <p:nvPr/>
        </p:nvSpPr>
        <p:spPr>
          <a:xfrm>
            <a:off x="9873409" y="3503128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err="1">
                <a:solidFill>
                  <a:srgbClr val="FF0000"/>
                </a:solidFill>
              </a:rPr>
              <a:t>pERK</a:t>
            </a:r>
            <a:endParaRPr lang="en-US" b="1">
              <a:solidFill>
                <a:srgbClr val="FF0000"/>
              </a:solidFill>
            </a:endParaRPr>
          </a:p>
        </p:txBody>
      </p:sp>
      <p:pic>
        <p:nvPicPr>
          <p:cNvPr id="12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802AFA6A-BF24-7DC0-357E-F87DEC03F32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7966" r="34356" b="32726"/>
          <a:stretch>
            <a:fillRect/>
          </a:stretch>
        </p:blipFill>
        <p:spPr bwMode="auto">
          <a:xfrm>
            <a:off x="1870192" y="3049673"/>
            <a:ext cx="2122085" cy="16455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2547390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429F49D-0B15-8023-E666-A197F10A88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91C07623-F2DE-8459-B764-313F85A977B1}"/>
              </a:ext>
            </a:extLst>
          </p:cNvPr>
          <p:cNvSpPr txBox="1"/>
          <p:nvPr/>
        </p:nvSpPr>
        <p:spPr>
          <a:xfrm>
            <a:off x="370936" y="336430"/>
            <a:ext cx="43633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E</a:t>
            </a:r>
          </a:p>
        </p:txBody>
      </p:sp>
      <p:pic>
        <p:nvPicPr>
          <p:cNvPr id="21" name="Imagen 20" descr="Imagen que contiene computadora, horno&#10;&#10;El contenido generado por IA puede ser incorrecto.">
            <a:extLst>
              <a:ext uri="{FF2B5EF4-FFF2-40B4-BE49-F238E27FC236}">
                <a16:creationId xmlns:a16="http://schemas.microsoft.com/office/drawing/2014/main" id="{D76865D4-330B-FD05-0A55-FC216910A7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9660" y="963217"/>
            <a:ext cx="7200000" cy="5236364"/>
          </a:xfrm>
          <a:prstGeom prst="rect">
            <a:avLst/>
          </a:prstGeom>
        </p:spPr>
      </p:pic>
      <p:sp>
        <p:nvSpPr>
          <p:cNvPr id="3" name="Rectángulo 2">
            <a:extLst>
              <a:ext uri="{FF2B5EF4-FFF2-40B4-BE49-F238E27FC236}">
                <a16:creationId xmlns:a16="http://schemas.microsoft.com/office/drawing/2014/main" id="{4D2200D6-6F91-7F7B-E069-1859A174DAF4}"/>
              </a:ext>
            </a:extLst>
          </p:cNvPr>
          <p:cNvSpPr/>
          <p:nvPr/>
        </p:nvSpPr>
        <p:spPr>
          <a:xfrm>
            <a:off x="4853983" y="4380814"/>
            <a:ext cx="3211904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67FEC1EF-849A-E1F7-1AAE-DA961EB00473}"/>
              </a:ext>
            </a:extLst>
          </p:cNvPr>
          <p:cNvSpPr/>
          <p:nvPr/>
        </p:nvSpPr>
        <p:spPr>
          <a:xfrm>
            <a:off x="4034285" y="2266233"/>
            <a:ext cx="3211904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D97932E7-64A0-F9A6-AB38-8C76F4E17B4B}"/>
              </a:ext>
            </a:extLst>
          </p:cNvPr>
          <p:cNvSpPr txBox="1"/>
          <p:nvPr/>
        </p:nvSpPr>
        <p:spPr>
          <a:xfrm rot="16200000">
            <a:off x="5973791" y="2370639"/>
            <a:ext cx="100929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K656E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+)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79F18E4B-978A-4BF8-4460-6ADB9E1B12E4}"/>
              </a:ext>
            </a:extLst>
          </p:cNvPr>
          <p:cNvSpPr txBox="1"/>
          <p:nvPr/>
        </p:nvSpPr>
        <p:spPr>
          <a:xfrm rot="16200000">
            <a:off x="5135591" y="285888"/>
            <a:ext cx="100929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WT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WT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+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EC091E22-EA74-AFFF-5C77-831FAB8117A9}"/>
              </a:ext>
            </a:extLst>
          </p:cNvPr>
          <p:cNvSpPr txBox="1"/>
          <p:nvPr/>
        </p:nvSpPr>
        <p:spPr>
          <a:xfrm>
            <a:off x="9493536" y="2374865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ERK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9D346080-94C5-6B3A-A733-25F80D7A8E6F}"/>
              </a:ext>
            </a:extLst>
          </p:cNvPr>
          <p:cNvSpPr txBox="1"/>
          <p:nvPr/>
        </p:nvSpPr>
        <p:spPr>
          <a:xfrm>
            <a:off x="11151073" y="4489446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ERK</a:t>
            </a:r>
          </a:p>
        </p:txBody>
      </p:sp>
      <p:pic>
        <p:nvPicPr>
          <p:cNvPr id="10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598AAFFA-F49F-9CD9-D5E6-6D8596F99D4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7966" r="34356" b="32726"/>
          <a:stretch>
            <a:fillRect/>
          </a:stretch>
        </p:blipFill>
        <p:spPr bwMode="auto">
          <a:xfrm>
            <a:off x="1144186" y="1840599"/>
            <a:ext cx="2330507" cy="18071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8D75D9C1-B3D5-C118-0CD1-BAF7813B813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7966" r="34356" b="32726"/>
          <a:stretch>
            <a:fillRect/>
          </a:stretch>
        </p:blipFill>
        <p:spPr bwMode="auto">
          <a:xfrm>
            <a:off x="8676706" y="3817189"/>
            <a:ext cx="2330507" cy="18071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809756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0919E6E-2B33-6C38-3975-BB7E1A97F23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63D076AB-CDA4-5696-240D-72EE2409394B}"/>
              </a:ext>
            </a:extLst>
          </p:cNvPr>
          <p:cNvSpPr txBox="1"/>
          <p:nvPr/>
        </p:nvSpPr>
        <p:spPr>
          <a:xfrm>
            <a:off x="370936" y="336430"/>
            <a:ext cx="43633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E</a:t>
            </a:r>
          </a:p>
        </p:txBody>
      </p:sp>
      <p:pic>
        <p:nvPicPr>
          <p:cNvPr id="19" name="Imagen 18" descr="Imagen que contiene horno&#10;&#10;El contenido generado por IA puede ser incorrecto.">
            <a:extLst>
              <a:ext uri="{FF2B5EF4-FFF2-40B4-BE49-F238E27FC236}">
                <a16:creationId xmlns:a16="http://schemas.microsoft.com/office/drawing/2014/main" id="{F890D207-1507-512E-B4E5-96E567A4E6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6144" y="1553674"/>
            <a:ext cx="7200000" cy="5236364"/>
          </a:xfrm>
          <a:prstGeom prst="rect">
            <a:avLst/>
          </a:prstGeom>
        </p:spPr>
      </p:pic>
      <p:pic>
        <p:nvPicPr>
          <p:cNvPr id="4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28A11910-BF87-92B4-7268-7E5E187FBD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7966" r="34356" b="49758"/>
          <a:stretch>
            <a:fillRect/>
          </a:stretch>
        </p:blipFill>
        <p:spPr bwMode="auto">
          <a:xfrm>
            <a:off x="2365856" y="2109833"/>
            <a:ext cx="2330507" cy="756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70D0A133-518D-E041-7BCA-5C7F54213ADD}"/>
              </a:ext>
            </a:extLst>
          </p:cNvPr>
          <p:cNvSpPr/>
          <p:nvPr/>
        </p:nvSpPr>
        <p:spPr>
          <a:xfrm>
            <a:off x="5694241" y="4078711"/>
            <a:ext cx="3211904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0F5FB701-7664-7861-8C5D-DA9EDF1DCE04}"/>
              </a:ext>
            </a:extLst>
          </p:cNvPr>
          <p:cNvSpPr/>
          <p:nvPr/>
        </p:nvSpPr>
        <p:spPr>
          <a:xfrm>
            <a:off x="4874543" y="1964130"/>
            <a:ext cx="3211904" cy="586596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DC685A03-CCA0-A590-CA89-7ABF725C5C1D}"/>
              </a:ext>
            </a:extLst>
          </p:cNvPr>
          <p:cNvSpPr txBox="1"/>
          <p:nvPr/>
        </p:nvSpPr>
        <p:spPr>
          <a:xfrm rot="16200000">
            <a:off x="6814049" y="2068536"/>
            <a:ext cx="100929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K656E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K656E-R661P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R661P (+)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8C5253C9-889F-28AC-554E-DAA0D9B936C6}"/>
              </a:ext>
            </a:extLst>
          </p:cNvPr>
          <p:cNvSpPr txBox="1"/>
          <p:nvPr/>
        </p:nvSpPr>
        <p:spPr>
          <a:xfrm rot="16200000">
            <a:off x="5975849" y="-16215"/>
            <a:ext cx="100929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solidFill>
                  <a:srgbClr val="FF0000"/>
                </a:solidFill>
              </a:rPr>
              <a:t>WT (-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WT (+)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 (+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-) </a:t>
            </a:r>
          </a:p>
          <a:p>
            <a:endParaRPr lang="en-US" sz="1400" b="1">
              <a:solidFill>
                <a:srgbClr val="FF0000"/>
              </a:solidFill>
            </a:endParaRPr>
          </a:p>
          <a:p>
            <a:r>
              <a:rPr lang="en-US" sz="1400" b="1">
                <a:solidFill>
                  <a:srgbClr val="FF0000"/>
                </a:solidFill>
              </a:rPr>
              <a:t>N546K-R661P (+)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80831F90-619D-58B0-001F-724ED0B15537}"/>
              </a:ext>
            </a:extLst>
          </p:cNvPr>
          <p:cNvSpPr txBox="1"/>
          <p:nvPr/>
        </p:nvSpPr>
        <p:spPr>
          <a:xfrm>
            <a:off x="9995512" y="2072762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Tubulin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E546403E-7B29-B6EC-DD91-BFEE72884329}"/>
              </a:ext>
            </a:extLst>
          </p:cNvPr>
          <p:cNvSpPr txBox="1"/>
          <p:nvPr/>
        </p:nvSpPr>
        <p:spPr>
          <a:xfrm>
            <a:off x="9982214" y="4165625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Tubulin</a:t>
            </a:r>
          </a:p>
        </p:txBody>
      </p:sp>
      <p:pic>
        <p:nvPicPr>
          <p:cNvPr id="13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7F52B676-4CB3-30A0-4FD9-FFB85A532F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7966" r="34356" b="49758"/>
          <a:stretch>
            <a:fillRect/>
          </a:stretch>
        </p:blipFill>
        <p:spPr bwMode="auto">
          <a:xfrm>
            <a:off x="2256293" y="4202281"/>
            <a:ext cx="2330507" cy="756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491560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84499B-DF6B-8EA7-EC75-7D96AE85F1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n 16" descr="Imagen que contiene refrigerador, lado, hombre&#10;&#10;El contenido generado por IA puede ser incorrecto.">
            <a:extLst>
              <a:ext uri="{FF2B5EF4-FFF2-40B4-BE49-F238E27FC236}">
                <a16:creationId xmlns:a16="http://schemas.microsoft.com/office/drawing/2014/main" id="{2B094CBA-5D2E-DA09-FBCA-8EA66A4704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6066" y="481595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11298C0A-86EA-4CB7-C3A8-BEA4328DCE6F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52C1EF61-85F1-8190-3BFF-7359F34CFEB6}"/>
              </a:ext>
            </a:extLst>
          </p:cNvPr>
          <p:cNvSpPr/>
          <p:nvPr/>
        </p:nvSpPr>
        <p:spPr>
          <a:xfrm>
            <a:off x="3330331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7B324FE0-6CFC-5765-14DB-68737A08FE8C}"/>
              </a:ext>
            </a:extLst>
          </p:cNvPr>
          <p:cNvSpPr txBox="1"/>
          <p:nvPr/>
        </p:nvSpPr>
        <p:spPr>
          <a:xfrm rot="16200000">
            <a:off x="5350409" y="-1043463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82417E60-6ED3-66E1-AEC8-70E1748B1183}"/>
              </a:ext>
            </a:extLst>
          </p:cNvPr>
          <p:cNvSpPr txBox="1"/>
          <p:nvPr/>
        </p:nvSpPr>
        <p:spPr>
          <a:xfrm>
            <a:off x="9419953" y="2635559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pFGFR1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8975EDFF-F76A-B762-B9BD-D7C75BB3EED3}"/>
              </a:ext>
            </a:extLst>
          </p:cNvPr>
          <p:cNvSpPr/>
          <p:nvPr/>
        </p:nvSpPr>
        <p:spPr>
          <a:xfrm>
            <a:off x="5937848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20226C61-8D66-6FFE-1FD1-F59AE22A93D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1421460" y="2216312"/>
            <a:ext cx="1806927" cy="17669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549927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DA605E3-327C-5088-A2FE-D486310CAB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n 11" descr="Imagen que contiene interior, horno, abrir, puerta&#10;&#10;El contenido generado por IA puede ser incorrecto.">
            <a:extLst>
              <a:ext uri="{FF2B5EF4-FFF2-40B4-BE49-F238E27FC236}">
                <a16:creationId xmlns:a16="http://schemas.microsoft.com/office/drawing/2014/main" id="{B4393E07-E9C0-4A9C-9638-267BEA88B9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8364" y="263412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356C9B0F-8931-7310-9AAE-BA6E116D9E2D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48842EC2-A077-1AA3-BE0E-1A54EAC78D47}"/>
              </a:ext>
            </a:extLst>
          </p:cNvPr>
          <p:cNvSpPr/>
          <p:nvPr/>
        </p:nvSpPr>
        <p:spPr>
          <a:xfrm>
            <a:off x="3671338" y="4097028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38BA8EEC-0283-E8A6-1626-8DFBA25E3E30}"/>
              </a:ext>
            </a:extLst>
          </p:cNvPr>
          <p:cNvSpPr txBox="1"/>
          <p:nvPr/>
        </p:nvSpPr>
        <p:spPr>
          <a:xfrm rot="16200000">
            <a:off x="5691416" y="418006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WT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D571BC56-9E91-3C72-7DB7-550216AC4A88}"/>
              </a:ext>
            </a:extLst>
          </p:cNvPr>
          <p:cNvSpPr txBox="1"/>
          <p:nvPr/>
        </p:nvSpPr>
        <p:spPr>
          <a:xfrm>
            <a:off x="1662227" y="4264954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Tubulin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882268D0-F221-0728-0D84-776F5FECE665}"/>
              </a:ext>
            </a:extLst>
          </p:cNvPr>
          <p:cNvSpPr/>
          <p:nvPr/>
        </p:nvSpPr>
        <p:spPr>
          <a:xfrm>
            <a:off x="6278855" y="4097028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18BD31E7-F498-7991-A025-C303D9C0E19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0711" r="34356" b="32726"/>
          <a:stretch>
            <a:fillRect/>
          </a:stretch>
        </p:blipFill>
        <p:spPr bwMode="auto">
          <a:xfrm>
            <a:off x="8928354" y="3607834"/>
            <a:ext cx="2122085" cy="20529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888819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3BDE137-C658-984A-57FD-4C45186268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n 10">
            <a:extLst>
              <a:ext uri="{FF2B5EF4-FFF2-40B4-BE49-F238E27FC236}">
                <a16:creationId xmlns:a16="http://schemas.microsoft.com/office/drawing/2014/main" id="{6500BA66-A5A5-80EC-0711-024CD359EA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4696" y="1472177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75A22D13-DF88-222C-6083-DA5DCFBDD55D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9664000B-7A84-18D0-98C4-4692E137F22C}"/>
              </a:ext>
            </a:extLst>
          </p:cNvPr>
          <p:cNvSpPr/>
          <p:nvPr/>
        </p:nvSpPr>
        <p:spPr>
          <a:xfrm>
            <a:off x="3330331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A273DD7F-F683-45AA-5972-56666BE72055}"/>
              </a:ext>
            </a:extLst>
          </p:cNvPr>
          <p:cNvSpPr txBox="1"/>
          <p:nvPr/>
        </p:nvSpPr>
        <p:spPr>
          <a:xfrm rot="16200000">
            <a:off x="5350409" y="-1043463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28EB640E-5DEB-67A4-7AB2-F35AE623AB34}"/>
              </a:ext>
            </a:extLst>
          </p:cNvPr>
          <p:cNvSpPr txBox="1"/>
          <p:nvPr/>
        </p:nvSpPr>
        <p:spPr>
          <a:xfrm>
            <a:off x="8936874" y="2719522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750D1DDE-1F5D-F4F7-6866-441637326762}"/>
              </a:ext>
            </a:extLst>
          </p:cNvPr>
          <p:cNvSpPr/>
          <p:nvPr/>
        </p:nvSpPr>
        <p:spPr>
          <a:xfrm>
            <a:off x="5937848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727E8DBC-22B9-58CF-5655-19271DF172E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1127737" y="2104845"/>
            <a:ext cx="1920917" cy="18783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142773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BC66DC-EAB0-8A22-B554-BCD9AAC5B7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 descr="Imagen que contiene interior, ventana, refrigerador, hombre&#10;&#10;El contenido generado por IA puede ser incorrecto.">
            <a:extLst>
              <a:ext uri="{FF2B5EF4-FFF2-40B4-BE49-F238E27FC236}">
                <a16:creationId xmlns:a16="http://schemas.microsoft.com/office/drawing/2014/main" id="{59C2900E-07A0-4A9B-6CDE-83A9F47681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572" y="1198942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477C4913-4C76-9F25-44AE-E6A5EAACF740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0032926A-302F-18C8-F62F-2A6D70191C34}"/>
              </a:ext>
            </a:extLst>
          </p:cNvPr>
          <p:cNvSpPr/>
          <p:nvPr/>
        </p:nvSpPr>
        <p:spPr>
          <a:xfrm>
            <a:off x="3330331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DF289DCD-DB4F-95B3-83E2-81F97AF3EB5A}"/>
              </a:ext>
            </a:extLst>
          </p:cNvPr>
          <p:cNvSpPr txBox="1"/>
          <p:nvPr/>
        </p:nvSpPr>
        <p:spPr>
          <a:xfrm rot="16200000">
            <a:off x="5350409" y="-1043463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2C830A0B-9588-04F8-99E3-464003A3148C}"/>
              </a:ext>
            </a:extLst>
          </p:cNvPr>
          <p:cNvSpPr txBox="1"/>
          <p:nvPr/>
        </p:nvSpPr>
        <p:spPr>
          <a:xfrm>
            <a:off x="9419953" y="2635559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pFGFR1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66192004-C087-BB5F-59E1-EA2BD40B45CC}"/>
              </a:ext>
            </a:extLst>
          </p:cNvPr>
          <p:cNvSpPr/>
          <p:nvPr/>
        </p:nvSpPr>
        <p:spPr>
          <a:xfrm>
            <a:off x="5937848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7873625B-0398-5232-89F8-D1D83EE3BA0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1241727" y="2216312"/>
            <a:ext cx="1806927" cy="17669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389195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C7235EC-2404-FF78-3CB2-A1968CBA8C1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que contiene interior, horno, abrir, puerta&#10;&#10;El contenido generado por IA puede ser incorrecto.">
            <a:extLst>
              <a:ext uri="{FF2B5EF4-FFF2-40B4-BE49-F238E27FC236}">
                <a16:creationId xmlns:a16="http://schemas.microsoft.com/office/drawing/2014/main" id="{F250D2DD-AC53-949C-A24B-3B3A53D093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9953" y="607360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361ADA50-E5DE-5793-B0CF-F34AC7482B55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85F15DF3-7B04-3E9F-93D2-E908D96115A5}"/>
              </a:ext>
            </a:extLst>
          </p:cNvPr>
          <p:cNvSpPr/>
          <p:nvPr/>
        </p:nvSpPr>
        <p:spPr>
          <a:xfrm>
            <a:off x="3193171" y="440720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19292016-9F71-7AEB-FC84-67A4603A0278}"/>
              </a:ext>
            </a:extLst>
          </p:cNvPr>
          <p:cNvSpPr txBox="1"/>
          <p:nvPr/>
        </p:nvSpPr>
        <p:spPr>
          <a:xfrm rot="16200000">
            <a:off x="5213249" y="728187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CC1C3522-7209-25FB-2E48-57B8D1EB14A6}"/>
              </a:ext>
            </a:extLst>
          </p:cNvPr>
          <p:cNvSpPr txBox="1"/>
          <p:nvPr/>
        </p:nvSpPr>
        <p:spPr>
          <a:xfrm>
            <a:off x="9282793" y="4407209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Tubulin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D48D7AB2-824C-9FC0-747A-270A3D05AA6D}"/>
              </a:ext>
            </a:extLst>
          </p:cNvPr>
          <p:cNvSpPr/>
          <p:nvPr/>
        </p:nvSpPr>
        <p:spPr>
          <a:xfrm>
            <a:off x="5800688" y="440720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1A76A59E-1913-E8A7-501F-11D2AE89E99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0711" r="34356" b="32726"/>
          <a:stretch>
            <a:fillRect/>
          </a:stretch>
        </p:blipFill>
        <p:spPr bwMode="auto">
          <a:xfrm>
            <a:off x="291559" y="3429000"/>
            <a:ext cx="2122085" cy="20529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912938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692F5B-2CF6-4EDD-58CB-C66F4E3783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n 8" descr="Imagen que contiene refrigerador, hombre&#10;&#10;El contenido generado por IA puede ser incorrecto.">
            <a:extLst>
              <a:ext uri="{FF2B5EF4-FFF2-40B4-BE49-F238E27FC236}">
                <a16:creationId xmlns:a16="http://schemas.microsoft.com/office/drawing/2014/main" id="{55D4F97D-D258-A04D-A065-173C28E324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9963" y="856820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22BE9790-89AB-1E1A-5A39-CE8AB272EAE3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C851691A-B491-BF40-9519-D16EA45F1AFD}"/>
              </a:ext>
            </a:extLst>
          </p:cNvPr>
          <p:cNvSpPr/>
          <p:nvPr/>
        </p:nvSpPr>
        <p:spPr>
          <a:xfrm>
            <a:off x="3330331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A1E8B5BB-E618-3D1D-6780-A5B9F7FC2E9C}"/>
              </a:ext>
            </a:extLst>
          </p:cNvPr>
          <p:cNvSpPr txBox="1"/>
          <p:nvPr/>
        </p:nvSpPr>
        <p:spPr>
          <a:xfrm rot="16200000">
            <a:off x="5350409" y="-1043463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CE5CB8E8-9C75-5910-A438-42B0F408BC3B}"/>
              </a:ext>
            </a:extLst>
          </p:cNvPr>
          <p:cNvSpPr txBox="1"/>
          <p:nvPr/>
        </p:nvSpPr>
        <p:spPr>
          <a:xfrm>
            <a:off x="9419953" y="2635559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A84A7692-158E-387F-0DEB-E9239FB44F60}"/>
              </a:ext>
            </a:extLst>
          </p:cNvPr>
          <p:cNvSpPr/>
          <p:nvPr/>
        </p:nvSpPr>
        <p:spPr>
          <a:xfrm>
            <a:off x="5937848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834A49E3-12AB-CB22-FBFE-5BFECEAEDAB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1127737" y="2104845"/>
            <a:ext cx="1920917" cy="18783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338367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CA36FA-D6E0-1021-FCD6-481549402F9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que contiene refrigerador, cocina&#10;&#10;El contenido generado por IA puede ser incorrecto.">
            <a:extLst>
              <a:ext uri="{FF2B5EF4-FFF2-40B4-BE49-F238E27FC236}">
                <a16:creationId xmlns:a16="http://schemas.microsoft.com/office/drawing/2014/main" id="{56C6EF1A-4BDA-FCEC-93D9-21144BF74D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570" y="1630262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9DF1EE44-1892-9C6B-2C05-AE238972209C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851A4A92-5DE8-75A4-6D87-81677443B3E0}"/>
              </a:ext>
            </a:extLst>
          </p:cNvPr>
          <p:cNvSpPr/>
          <p:nvPr/>
        </p:nvSpPr>
        <p:spPr>
          <a:xfrm>
            <a:off x="3330331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00F42273-78C1-B1AB-9013-C58F3FAC362B}"/>
              </a:ext>
            </a:extLst>
          </p:cNvPr>
          <p:cNvSpPr txBox="1"/>
          <p:nvPr/>
        </p:nvSpPr>
        <p:spPr>
          <a:xfrm rot="16200000">
            <a:off x="5350409" y="-1043463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7926ABAE-043F-F474-8793-1ADDAE00BFC8}"/>
              </a:ext>
            </a:extLst>
          </p:cNvPr>
          <p:cNvSpPr txBox="1"/>
          <p:nvPr/>
        </p:nvSpPr>
        <p:spPr>
          <a:xfrm>
            <a:off x="9419953" y="2635559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pFGFR1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4589D029-2ED4-9BE1-C114-B38628453839}"/>
              </a:ext>
            </a:extLst>
          </p:cNvPr>
          <p:cNvSpPr/>
          <p:nvPr/>
        </p:nvSpPr>
        <p:spPr>
          <a:xfrm>
            <a:off x="5937848" y="2635559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1628737B-6B4E-4692-5579-C764BD35815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1127737" y="2104845"/>
            <a:ext cx="1920917" cy="18783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043523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3050CD-237F-5A27-2F27-FB9B68EA32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Imagen que contiene refrigerador, computadora&#10;&#10;El contenido generado por IA puede ser incorrecto.">
            <a:extLst>
              <a:ext uri="{FF2B5EF4-FFF2-40B4-BE49-F238E27FC236}">
                <a16:creationId xmlns:a16="http://schemas.microsoft.com/office/drawing/2014/main" id="{A56AF7E8-7F3A-1E6A-F66E-1BAECFD4DC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0096" y="521096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CE84E2BF-0600-7F03-837E-EE1E3DD50C18}"/>
              </a:ext>
            </a:extLst>
          </p:cNvPr>
          <p:cNvSpPr txBox="1"/>
          <p:nvPr/>
        </p:nvSpPr>
        <p:spPr>
          <a:xfrm>
            <a:off x="370936" y="336430"/>
            <a:ext cx="46679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3D</a:t>
            </a:r>
          </a:p>
        </p:txBody>
      </p:sp>
      <p:sp>
        <p:nvSpPr>
          <p:cNvPr id="38" name="Rectángulo 37">
            <a:extLst>
              <a:ext uri="{FF2B5EF4-FFF2-40B4-BE49-F238E27FC236}">
                <a16:creationId xmlns:a16="http://schemas.microsoft.com/office/drawing/2014/main" id="{A0901730-FEEB-40D4-F7FC-CC335E9F7029}"/>
              </a:ext>
            </a:extLst>
          </p:cNvPr>
          <p:cNvSpPr/>
          <p:nvPr/>
        </p:nvSpPr>
        <p:spPr>
          <a:xfrm>
            <a:off x="3488483" y="3883591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44FE10BB-3227-C554-EB7E-AB3EA7B1BB5E}"/>
              </a:ext>
            </a:extLst>
          </p:cNvPr>
          <p:cNvSpPr txBox="1"/>
          <p:nvPr/>
        </p:nvSpPr>
        <p:spPr>
          <a:xfrm rot="16200000">
            <a:off x="5508561" y="204569"/>
            <a:ext cx="1784480" cy="5642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12h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 24h 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0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8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12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>
                <a:solidFill>
                  <a:srgbClr val="FF0000"/>
                </a:solidFill>
              </a:rPr>
              <a:t>R661P 24h</a:t>
            </a: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>
              <a:solidFill>
                <a:srgbClr val="FF0000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02827893-C506-32E2-892A-0ECA215E84CC}"/>
              </a:ext>
            </a:extLst>
          </p:cNvPr>
          <p:cNvSpPr txBox="1"/>
          <p:nvPr/>
        </p:nvSpPr>
        <p:spPr>
          <a:xfrm>
            <a:off x="9601148" y="4026803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Tubulin</a:t>
            </a:r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DB9A7546-B950-A9A5-02F9-4659BBC40D4A}"/>
              </a:ext>
            </a:extLst>
          </p:cNvPr>
          <p:cNvSpPr/>
          <p:nvPr/>
        </p:nvSpPr>
        <p:spPr>
          <a:xfrm>
            <a:off x="6096000" y="3883591"/>
            <a:ext cx="2552884" cy="537258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38A07ADD-14E5-FAB3-4B69-066A91403D0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0711" r="34356" b="32726"/>
          <a:stretch>
            <a:fillRect/>
          </a:stretch>
        </p:blipFill>
        <p:spPr bwMode="auto">
          <a:xfrm>
            <a:off x="1320881" y="3414615"/>
            <a:ext cx="2122085" cy="20529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781502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b06b1ac-b6cc-4c25-bfb7-551e20c80d5c">
      <Terms xmlns="http://schemas.microsoft.com/office/infopath/2007/PartnerControls"/>
    </lcf76f155ced4ddcb4097134ff3c332f>
    <_ip_UnifiedCompliancePolicyUIAction xmlns="http://schemas.microsoft.com/sharepoint/v3" xsi:nil="true"/>
    <_ip_UnifiedCompliancePolicyProperties xmlns="http://schemas.microsoft.com/sharepoint/v3" xsi:nil="true"/>
    <experiment xmlns="3b06b1ac-b6cc-4c25-bfb7-551e20c80d5c" xsi:nil="true"/>
    <TaxCatchAll xmlns="e060ecb7-dcf7-4a45-ada8-96d79a1fb1be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2784A8EC112FF47A12A49FA34F89301" ma:contentTypeVersion="19" ma:contentTypeDescription="Crear nuevo documento." ma:contentTypeScope="" ma:versionID="3a523e80048e49ca689ccbbead60cdeb">
  <xsd:schema xmlns:xsd="http://www.w3.org/2001/XMLSchema" xmlns:xs="http://www.w3.org/2001/XMLSchema" xmlns:p="http://schemas.microsoft.com/office/2006/metadata/properties" xmlns:ns1="http://schemas.microsoft.com/sharepoint/v3" xmlns:ns2="3b06b1ac-b6cc-4c25-bfb7-551e20c80d5c" xmlns:ns3="e060ecb7-dcf7-4a45-ada8-96d79a1fb1be" targetNamespace="http://schemas.microsoft.com/office/2006/metadata/properties" ma:root="true" ma:fieldsID="bb7710ec5d278677887808aadfeb7836" ns1:_="" ns2:_="" ns3:_="">
    <xsd:import namespace="http://schemas.microsoft.com/sharepoint/v3"/>
    <xsd:import namespace="3b06b1ac-b6cc-4c25-bfb7-551e20c80d5c"/>
    <xsd:import namespace="e060ecb7-dcf7-4a45-ada8-96d79a1fb1b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Locatio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3:SharedWithUsers" minOccurs="0"/>
                <xsd:element ref="ns3:SharedWithDetails" minOccurs="0"/>
                <xsd:element ref="ns2:experiment" minOccurs="0"/>
                <xsd:element ref="ns1:_ip_UnifiedCompliancePolicyProperties" minOccurs="0"/>
                <xsd:element ref="ns1:_ip_UnifiedCompliancePolicyUIAction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4" nillable="true" ma:displayName="Propiedades de la Directiva de cumplimiento unificado" ma:hidden="true" ma:internalName="_ip_UnifiedCompliancePolicyProperties">
      <xsd:simpleType>
        <xsd:restriction base="dms:Note"/>
      </xsd:simpleType>
    </xsd:element>
    <xsd:element name="_ip_UnifiedCompliancePolicyUIAction" ma:index="25" nillable="true" ma:displayName="Acción de IU de la Directiva de cumplimiento unificado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06b1ac-b6cc-4c25-bfb7-551e20c80d5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8" nillable="true" ma:taxonomy="true" ma:internalName="lcf76f155ced4ddcb4097134ff3c332f" ma:taxonomyFieldName="MediaServiceImageTags" ma:displayName="Etiquetas de imagen" ma:readOnly="false" ma:fieldId="{5cf76f15-5ced-4ddc-b409-7134ff3c332f}" ma:taxonomyMulti="true" ma:sspId="060dc275-4b37-4471-97cc-e467d34dad9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experiment" ma:index="23" nillable="true" ma:displayName="experiment" ma:format="Dropdown" ma:internalName="experiment">
      <xsd:simpleType>
        <xsd:restriction base="dms:Text">
          <xsd:maxLength value="255"/>
        </xsd:restriction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060ecb7-dcf7-4a45-ada8-96d79a1fb1be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e1f92d22-2900-48ef-9cf0-36df0f5fa8f8}" ma:internalName="TaxCatchAll" ma:showField="CatchAllData" ma:web="e060ecb7-dcf7-4a45-ada8-96d79a1fb1b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F7AEF27-12CF-4E6A-A4C3-0C70AB873B03}">
  <ds:schemaRefs>
    <ds:schemaRef ds:uri="3b06b1ac-b6cc-4c25-bfb7-551e20c80d5c"/>
    <ds:schemaRef ds:uri="e060ecb7-dcf7-4a45-ada8-96d79a1fb1be"/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customXml/itemProps2.xml><?xml version="1.0" encoding="utf-8"?>
<ds:datastoreItem xmlns:ds="http://schemas.openxmlformats.org/officeDocument/2006/customXml" ds:itemID="{19958082-6C40-488A-8135-0A38B0E6EB72}">
  <ds:schemaRefs>
    <ds:schemaRef ds:uri="3b06b1ac-b6cc-4c25-bfb7-551e20c80d5c"/>
    <ds:schemaRef ds:uri="e060ecb7-dcf7-4a45-ada8-96d79a1fb1b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B975D885-2EFD-43D8-9F27-DFF974AB0B7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8</Words>
  <Application>Microsoft Office PowerPoint</Application>
  <PresentationFormat>Panorámica</PresentationFormat>
  <Paragraphs>293</Paragraphs>
  <Slides>1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4</vt:i4>
      </vt:variant>
    </vt:vector>
  </HeadingPairs>
  <TitlesOfParts>
    <vt:vector size="18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Jacopo Boni</cp:lastModifiedBy>
  <cp:revision>1</cp:revision>
  <dcterms:created xsi:type="dcterms:W3CDTF">2025-07-23T10:06:09Z</dcterms:created>
  <dcterms:modified xsi:type="dcterms:W3CDTF">2025-09-08T15:14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2784A8EC112FF47A12A49FA34F89301</vt:lpwstr>
  </property>
  <property fmtid="{D5CDD505-2E9C-101B-9397-08002B2CF9AE}" pid="3" name="MediaServiceImageTags">
    <vt:lpwstr/>
  </property>
</Properties>
</file>